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4"/>
  </p:notesMasterIdLst>
  <p:sldIdLst>
    <p:sldId id="5975" r:id="rId2"/>
    <p:sldId id="257" r:id="rId3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766"/>
    <p:restoredTop sz="94779"/>
  </p:normalViewPr>
  <p:slideViewPr>
    <p:cSldViewPr snapToGrid="0">
      <p:cViewPr varScale="1">
        <p:scale>
          <a:sx n="101" d="100"/>
          <a:sy n="101" d="100"/>
        </p:scale>
        <p:origin x="2296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B0D8923-5C29-A040-BCF4-136B17F3305A}" type="datetimeFigureOut">
              <a:rPr lang="en-US" smtClean="0"/>
              <a:t>1/21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B1563E1-3F1D-E64E-9CAD-2CF8F37E37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356973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EE51A4-5CD0-874C-99AC-F783733B957E}" type="datetimeFigureOut">
              <a:rPr lang="en-US" smtClean="0"/>
              <a:t>1/2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49317A-20A4-A641-8123-AC75D95438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72931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EE51A4-5CD0-874C-99AC-F783733B957E}" type="datetimeFigureOut">
              <a:rPr lang="en-US" smtClean="0"/>
              <a:t>1/2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49317A-20A4-A641-8123-AC75D95438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91507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3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3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EE51A4-5CD0-874C-99AC-F783733B957E}" type="datetimeFigureOut">
              <a:rPr lang="en-US" smtClean="0"/>
              <a:t>1/2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49317A-20A4-A641-8123-AC75D95438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7411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EE51A4-5CD0-874C-99AC-F783733B957E}" type="datetimeFigureOut">
              <a:rPr lang="en-US" smtClean="0"/>
              <a:t>1/2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49317A-20A4-A641-8123-AC75D95438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30163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EE51A4-5CD0-874C-99AC-F783733B957E}" type="datetimeFigureOut">
              <a:rPr lang="en-US" smtClean="0"/>
              <a:t>1/2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49317A-20A4-A641-8123-AC75D95438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53425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EE51A4-5CD0-874C-99AC-F783733B957E}" type="datetimeFigureOut">
              <a:rPr lang="en-US" smtClean="0"/>
              <a:t>1/21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49317A-20A4-A641-8123-AC75D95438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11415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5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EE51A4-5CD0-874C-99AC-F783733B957E}" type="datetimeFigureOut">
              <a:rPr lang="en-US" smtClean="0"/>
              <a:t>1/21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49317A-20A4-A641-8123-AC75D95438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31831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EE51A4-5CD0-874C-99AC-F783733B957E}" type="datetimeFigureOut">
              <a:rPr lang="en-US" smtClean="0"/>
              <a:t>1/21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49317A-20A4-A641-8123-AC75D95438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80578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EE51A4-5CD0-874C-99AC-F783733B957E}" type="datetimeFigureOut">
              <a:rPr lang="en-US" smtClean="0"/>
              <a:t>1/21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49317A-20A4-A641-8123-AC75D95438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90950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8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EE51A4-5CD0-874C-99AC-F783733B957E}" type="datetimeFigureOut">
              <a:rPr lang="en-US" smtClean="0"/>
              <a:t>1/21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49317A-20A4-A641-8123-AC75D95438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47035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8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EE51A4-5CD0-874C-99AC-F783733B957E}" type="datetimeFigureOut">
              <a:rPr lang="en-US" smtClean="0"/>
              <a:t>1/21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49317A-20A4-A641-8123-AC75D95438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69406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5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4EE51A4-5CD0-874C-99AC-F783733B957E}" type="datetimeFigureOut">
              <a:rPr lang="en-US" smtClean="0"/>
              <a:t>1/2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649317A-20A4-A641-8123-AC75D95438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09391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48" name="Picture 1347">
            <a:extLst>
              <a:ext uri="{FF2B5EF4-FFF2-40B4-BE49-F238E27FC236}">
                <a16:creationId xmlns:a16="http://schemas.microsoft.com/office/drawing/2014/main" id="{E583B543-F100-26A7-40A2-38E4F628156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510" t="11040"/>
          <a:stretch/>
        </p:blipFill>
        <p:spPr>
          <a:xfrm>
            <a:off x="1051004" y="3423660"/>
            <a:ext cx="5029630" cy="2746367"/>
          </a:xfrm>
          <a:prstGeom prst="rect">
            <a:avLst/>
          </a:prstGeom>
        </p:spPr>
      </p:pic>
      <p:pic>
        <p:nvPicPr>
          <p:cNvPr id="1349" name="Picture 1348">
            <a:extLst>
              <a:ext uri="{FF2B5EF4-FFF2-40B4-BE49-F238E27FC236}">
                <a16:creationId xmlns:a16="http://schemas.microsoft.com/office/drawing/2014/main" id="{1AB85EB7-DBBD-F5A6-33E4-BA16EEF26759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10" t="10297"/>
          <a:stretch/>
        </p:blipFill>
        <p:spPr>
          <a:xfrm>
            <a:off x="1028700" y="6400799"/>
            <a:ext cx="4866495" cy="2638941"/>
          </a:xfrm>
          <a:prstGeom prst="rect">
            <a:avLst/>
          </a:prstGeom>
        </p:spPr>
      </p:pic>
      <p:pic>
        <p:nvPicPr>
          <p:cNvPr id="1350" name="Picture 1349">
            <a:extLst>
              <a:ext uri="{FF2B5EF4-FFF2-40B4-BE49-F238E27FC236}">
                <a16:creationId xmlns:a16="http://schemas.microsoft.com/office/drawing/2014/main" id="{EFAC4902-A449-C0C9-C0F2-EA8995B96C3B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464" t="9312"/>
          <a:stretch/>
        </p:blipFill>
        <p:spPr>
          <a:xfrm>
            <a:off x="1045881" y="799406"/>
            <a:ext cx="5039876" cy="2394849"/>
          </a:xfrm>
          <a:prstGeom prst="rect">
            <a:avLst/>
          </a:prstGeom>
        </p:spPr>
      </p:pic>
      <p:sp>
        <p:nvSpPr>
          <p:cNvPr id="1356" name="TextBox 1355">
            <a:extLst>
              <a:ext uri="{FF2B5EF4-FFF2-40B4-BE49-F238E27FC236}">
                <a16:creationId xmlns:a16="http://schemas.microsoft.com/office/drawing/2014/main" id="{1FAC0489-CBAC-B39C-E76D-B330071F669B}"/>
              </a:ext>
            </a:extLst>
          </p:cNvPr>
          <p:cNvSpPr txBox="1"/>
          <p:nvPr/>
        </p:nvSpPr>
        <p:spPr>
          <a:xfrm>
            <a:off x="901995" y="55486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357" name="TextBox 1356">
            <a:extLst>
              <a:ext uri="{FF2B5EF4-FFF2-40B4-BE49-F238E27FC236}">
                <a16:creationId xmlns:a16="http://schemas.microsoft.com/office/drawing/2014/main" id="{E320493E-683C-7ED4-A0DA-944DB0A294BC}"/>
              </a:ext>
            </a:extLst>
          </p:cNvPr>
          <p:cNvSpPr txBox="1"/>
          <p:nvPr/>
        </p:nvSpPr>
        <p:spPr>
          <a:xfrm>
            <a:off x="910584" y="3139173"/>
            <a:ext cx="303288" cy="290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86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358" name="TextBox 1357">
            <a:extLst>
              <a:ext uri="{FF2B5EF4-FFF2-40B4-BE49-F238E27FC236}">
                <a16:creationId xmlns:a16="http://schemas.microsoft.com/office/drawing/2014/main" id="{97A9D75A-A365-35A6-4AB3-C4689CFB6C62}"/>
              </a:ext>
            </a:extLst>
          </p:cNvPr>
          <p:cNvSpPr txBox="1"/>
          <p:nvPr/>
        </p:nvSpPr>
        <p:spPr>
          <a:xfrm>
            <a:off x="901995" y="6099161"/>
            <a:ext cx="303288" cy="290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86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F4B28701-FD4A-BBC0-948F-295B122F7DC5}"/>
              </a:ext>
            </a:extLst>
          </p:cNvPr>
          <p:cNvSpPr txBox="1"/>
          <p:nvPr/>
        </p:nvSpPr>
        <p:spPr>
          <a:xfrm>
            <a:off x="196948" y="181755"/>
            <a:ext cx="3432516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upplemental Figure 10 </a:t>
            </a:r>
            <a:endParaRPr lang="en-US" sz="1400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6DA30CDA-A60E-F8B3-76AA-88ACAFEC91E4}"/>
              </a:ext>
            </a:extLst>
          </p:cNvPr>
          <p:cNvSpPr txBox="1"/>
          <p:nvPr/>
        </p:nvSpPr>
        <p:spPr>
          <a:xfrm>
            <a:off x="1734228" y="554860"/>
            <a:ext cx="366318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OL1A1</a:t>
            </a:r>
            <a:r>
              <a:rPr lang="en-US" sz="12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– I</a:t>
            </a:r>
            <a:r>
              <a:rPr lang="en-US" sz="1200" b="1" baseline="30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954</a:t>
            </a:r>
            <a:r>
              <a:rPr lang="en-US" sz="12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GQRGVVGLP</a:t>
            </a:r>
            <a:r>
              <a:rPr lang="en-US" sz="1200" b="1" baseline="30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(ox)964 </a:t>
            </a:r>
            <a:r>
              <a:rPr lang="en-US" sz="12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– m/z 1082.63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6312AB7B-F13B-1C66-274F-F47E175D3D60}"/>
              </a:ext>
            </a:extLst>
          </p:cNvPr>
          <p:cNvSpPr txBox="1"/>
          <p:nvPr/>
        </p:nvSpPr>
        <p:spPr>
          <a:xfrm>
            <a:off x="1295005" y="3139173"/>
            <a:ext cx="45416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OL1A1</a:t>
            </a:r>
            <a:r>
              <a:rPr lang="en-US" sz="12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–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b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G</a:t>
            </a:r>
            <a:r>
              <a:rPr lang="en-US" sz="1200" b="1" baseline="300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656</a:t>
            </a:r>
            <a:r>
              <a:rPr lang="en-US" sz="1200" b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KP</a:t>
            </a:r>
            <a:r>
              <a:rPr lang="en-US" sz="1200" b="1" baseline="300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(ox)</a:t>
            </a:r>
            <a:r>
              <a:rPr lang="en-US" sz="1200" b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GEQGVP</a:t>
            </a:r>
            <a:r>
              <a:rPr lang="en-US" sz="1200" b="1" baseline="300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(ox)</a:t>
            </a:r>
            <a:r>
              <a:rPr lang="en-US" sz="1200" b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GDLGAP</a:t>
            </a:r>
            <a:r>
              <a:rPr lang="en-US" sz="1200" b="1" baseline="300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(ox)670</a:t>
            </a:r>
            <a:r>
              <a:rPr lang="en-US" sz="1200" b="1" baseline="30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sz="12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– m/z 1426.68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DDBFB2D-6CEA-E4EB-4DA6-3E722FFEA7F0}"/>
              </a:ext>
            </a:extLst>
          </p:cNvPr>
          <p:cNvSpPr txBox="1"/>
          <p:nvPr/>
        </p:nvSpPr>
        <p:spPr>
          <a:xfrm>
            <a:off x="1388781" y="6099161"/>
            <a:ext cx="43540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OL1A1</a:t>
            </a:r>
            <a:r>
              <a:rPr lang="en-US" sz="12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–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b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G</a:t>
            </a:r>
            <a:r>
              <a:rPr lang="en-US" sz="1200" b="1" baseline="300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656</a:t>
            </a:r>
            <a:r>
              <a:rPr lang="en-US" sz="1200" b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KP</a:t>
            </a:r>
            <a:r>
              <a:rPr lang="en-US" sz="1200" b="1" baseline="300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(ox)</a:t>
            </a:r>
            <a:r>
              <a:rPr lang="en-US" sz="1200" b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GEQGVPGDLGAP</a:t>
            </a:r>
            <a:r>
              <a:rPr lang="en-US" sz="1200" b="1" baseline="300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(ox)670</a:t>
            </a:r>
            <a:r>
              <a:rPr lang="en-US" sz="1200" b="1" baseline="30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sz="12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– m/z 1410.68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1471397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>
            <a:extLst>
              <a:ext uri="{FF2B5EF4-FFF2-40B4-BE49-F238E27FC236}">
                <a16:creationId xmlns:a16="http://schemas.microsoft.com/office/drawing/2014/main" id="{19B7B212-E303-E4EB-7E56-12C3FF115A9D}"/>
              </a:ext>
            </a:extLst>
          </p:cNvPr>
          <p:cNvSpPr txBox="1"/>
          <p:nvPr/>
        </p:nvSpPr>
        <p:spPr>
          <a:xfrm>
            <a:off x="244929" y="342900"/>
            <a:ext cx="6384471" cy="332398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/>
            <a:r>
              <a:rPr lang="en-US" sz="1400" b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upplemental Figure 10: MS/MS Spectra for Hydroxyproline-Modified Peptides. </a:t>
            </a:r>
            <a:r>
              <a:rPr lang="en-US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Data-Dependent Acquisition (DDA) MS/MS spectra of ions corresponding to MALDI-MSI features from Figure 6 matching peptides originating from Collagen alpha-1(I) (Col1A1) profiled with 1 or more modified hydroxyproline residues. Fragment ions from each precursor ion confirmed the identify of the modified hydroxyproline residues. (A) A singly modified peptide I</a:t>
            </a:r>
            <a:r>
              <a:rPr lang="en-US" sz="1400" baseline="300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954</a:t>
            </a:r>
            <a:r>
              <a:rPr lang="en-US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AGQRGVVGLP</a:t>
            </a:r>
            <a:r>
              <a:rPr lang="en-US" sz="1400" baseline="300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(ox)964</a:t>
            </a:r>
            <a:r>
              <a:rPr lang="en-US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, at m/z 1082.63 was detected with multiple y-ions containing the hydroxyproline residue from this precursor ion. (B) MS/MS spectra displaying fragment ions of the peptide G</a:t>
            </a:r>
            <a:r>
              <a:rPr lang="en-US" sz="1400" baseline="300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656</a:t>
            </a:r>
            <a:r>
              <a:rPr lang="en-US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KP</a:t>
            </a:r>
            <a:r>
              <a:rPr lang="en-US" sz="1400" baseline="300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(ox)</a:t>
            </a:r>
            <a:r>
              <a:rPr lang="en-US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GEQGVP</a:t>
            </a:r>
            <a:r>
              <a:rPr lang="en-US" sz="1400" baseline="300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(ox)</a:t>
            </a:r>
            <a:r>
              <a:rPr lang="en-US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GDLGAP</a:t>
            </a:r>
            <a:r>
              <a:rPr lang="en-US" sz="1400" baseline="300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(ox)670 </a:t>
            </a:r>
            <a:r>
              <a:rPr lang="en-US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at m/z 1426.68 containing 3 HYP residues. and (C) the peptide G</a:t>
            </a:r>
            <a:r>
              <a:rPr lang="en-US" sz="1400" baseline="300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656</a:t>
            </a:r>
            <a:r>
              <a:rPr lang="en-US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KP</a:t>
            </a:r>
            <a:r>
              <a:rPr lang="en-US" sz="1400" baseline="300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(ox)</a:t>
            </a:r>
            <a:r>
              <a:rPr lang="en-US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GEQGVPGDLGA P</a:t>
            </a:r>
            <a:r>
              <a:rPr lang="en-US" sz="1400" baseline="300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(ox)670 </a:t>
            </a:r>
            <a:r>
              <a:rPr lang="en-US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at m/z 1426.68 containing 2 HYP residues showed a mass shift in b- and y-ions at m/z by 16 m/z (15.994) at b</a:t>
            </a:r>
            <a:r>
              <a:rPr lang="en-US" sz="1400" baseline="-250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9</a:t>
            </a:r>
            <a:r>
              <a:rPr lang="en-US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and y</a:t>
            </a:r>
            <a:r>
              <a:rPr lang="en-US" sz="1400" baseline="-250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7</a:t>
            </a:r>
            <a:r>
              <a:rPr lang="en-US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lang="en-US" sz="1400" dirty="0">
                <a:latin typeface="Arial" panose="020B0604020202020204" pitchFamily="34" charset="0"/>
                <a:ea typeface="Times New Roman" panose="02020603050405020304" pitchFamily="18" charset="0"/>
              </a:rPr>
              <a:t>ions </a:t>
            </a:r>
            <a:r>
              <a:rPr lang="en-US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confirming the extra HYP modification. Note that in (C</a:t>
            </a:r>
            <a:r>
              <a:rPr lang="en-US" sz="140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) fragment </a:t>
            </a:r>
            <a:r>
              <a:rPr lang="en-US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ions b</a:t>
            </a:r>
            <a:r>
              <a:rPr lang="en-US" sz="1400" baseline="-250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6</a:t>
            </a:r>
            <a:r>
              <a:rPr lang="en-US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and y</a:t>
            </a:r>
            <a:r>
              <a:rPr lang="en-US" sz="1400" baseline="-250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13</a:t>
            </a:r>
            <a:r>
              <a:rPr lang="en-US" sz="1400" baseline="3000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++</a:t>
            </a:r>
            <a:r>
              <a:rPr lang="en-US" sz="140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shared </a:t>
            </a:r>
            <a:r>
              <a:rPr lang="en-US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the same m/z </a:t>
            </a:r>
            <a:r>
              <a:rPr lang="en-US" sz="140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in the MS</a:t>
            </a:r>
            <a:r>
              <a:rPr lang="en-US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/MS scans.</a:t>
            </a:r>
            <a:endParaRPr lang="en-US" sz="14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641754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3</TotalTime>
  <Words>269</Words>
  <Application>Microsoft Macintosh PowerPoint</Application>
  <PresentationFormat>Letter Paper (8.5x11 in)</PresentationFormat>
  <Paragraphs>8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ptos</vt:lpstr>
      <vt:lpstr>Aptos Display</vt:lpstr>
      <vt:lpstr>Arial</vt:lpstr>
      <vt:lpstr>Times New Roman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Charlie Schurman</dc:creator>
  <cp:lastModifiedBy>Birgit Schilling</cp:lastModifiedBy>
  <cp:revision>22</cp:revision>
  <dcterms:created xsi:type="dcterms:W3CDTF">2024-10-28T17:59:57Z</dcterms:created>
  <dcterms:modified xsi:type="dcterms:W3CDTF">2025-01-22T03:43:34Z</dcterms:modified>
</cp:coreProperties>
</file>